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7"/>
  </p:notesMasterIdLst>
  <p:sldIdLst>
    <p:sldId id="268" r:id="rId2"/>
    <p:sldId id="269" r:id="rId3"/>
    <p:sldId id="270" r:id="rId4"/>
    <p:sldId id="274" r:id="rId5"/>
    <p:sldId id="271" r:id="rId6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799"/>
    <p:restoredTop sz="94703"/>
  </p:normalViewPr>
  <p:slideViewPr>
    <p:cSldViewPr snapToGrid="0" snapToObjects="1">
      <p:cViewPr varScale="1">
        <p:scale>
          <a:sx n="97" d="100"/>
          <a:sy n="97" d="100"/>
        </p:scale>
        <p:origin x="520" y="1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A34D678-D436-FA43-AE56-74FDCD13C2AF}" type="datetimeFigureOut">
              <a:rPr lang="en-US" smtClean="0"/>
              <a:t>12/29/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9DD4096-1073-0247-8451-F46F306636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6916181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9DD4096-1073-0247-8451-F46F30663687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787987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D2C59C5-98A0-0B40-A46A-06DB0C7CE6E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1D685FBF-120F-C949-AF77-B10CD3F4344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3EC41F9-EAAC-264C-8578-965137F176A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00364C-B278-2843-8822-926DA20766C0}" type="datetimeFigureOut">
              <a:rPr lang="en-US" smtClean="0"/>
              <a:t>12/29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DB6BD62-FA75-B840-B6BA-ECD7BBE538C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1B99A0A-6EA8-5A4A-9C99-8DDAAAFF2A5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CC74D5-3AC8-1149-9CE2-5C62EA8712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1512777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401DA14-1189-7D41-8E02-4A6DC85C15D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84A5771-D44A-F040-A52F-6D0379ACC8F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A412C26-6B9B-5E4B-A6CB-8E0D4EE980D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00364C-B278-2843-8822-926DA20766C0}" type="datetimeFigureOut">
              <a:rPr lang="en-US" smtClean="0"/>
              <a:t>12/29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6B1D9E8-7D4C-5B4C-86A1-B93C6072DE4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1EB6DEE-BD80-C14E-A48D-FFF3CB7308D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CC74D5-3AC8-1149-9CE2-5C62EA8712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1433278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38557F5E-0257-8B4D-9D8C-31C464F0730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36A7FB2-D613-244D-9541-2D66E1690A0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7127453-3667-B541-81B4-D58A6552117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00364C-B278-2843-8822-926DA20766C0}" type="datetimeFigureOut">
              <a:rPr lang="en-US" smtClean="0"/>
              <a:t>12/29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44E2215-AF90-FE41-8532-07B25B67528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6B91B0A-0C8F-0C43-8047-221FD3D06C6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CC74D5-3AC8-1149-9CE2-5C62EA8712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588854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27F346D-03E5-AF4E-A7B3-43539431938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7838735-F797-5A43-B30A-A548FC4D597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91FFAAC-0F89-6F44-B7EC-7095143FFC0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00364C-B278-2843-8822-926DA20766C0}" type="datetimeFigureOut">
              <a:rPr lang="en-US" smtClean="0"/>
              <a:t>12/29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E668A2E-5CCF-284A-BAAD-919FA2BA7F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D1FB99A-2BD6-D94F-8BF4-6A53B07AFC6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CC74D5-3AC8-1149-9CE2-5C62EA8712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9407604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CAA4F80-E2BE-024C-9E98-7D8D654F1D3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8B00E9D-CB1E-1341-80D8-B104FC2EBA9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F801181-445D-1E49-8B4B-7CEE6335749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00364C-B278-2843-8822-926DA20766C0}" type="datetimeFigureOut">
              <a:rPr lang="en-US" smtClean="0"/>
              <a:t>12/29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A1F159B-6C16-E24D-B221-82B418314E6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C066CC9-9394-B346-BCA0-79CE8A0EE6E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CC74D5-3AC8-1149-9CE2-5C62EA8712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5847124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E745F8D-D2D4-0E41-8A5C-6FCB23B5A6D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B7CB9E3-4E9F-384C-9756-4D60BA322A1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F1EE524-5AC2-E74A-9B76-E0B41ECB223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F7F5D6B-A411-4A4F-9FA3-D99B2FD6DC1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00364C-B278-2843-8822-926DA20766C0}" type="datetimeFigureOut">
              <a:rPr lang="en-US" smtClean="0"/>
              <a:t>12/29/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D6C9AF9-4F5D-8E45-BF19-31C16DD9005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C171868-813C-694F-A513-6ED9E65611D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CC74D5-3AC8-1149-9CE2-5C62EA8712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4105252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15C88D4-A742-EC49-B84F-B7DE79104F5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F4608D0-E352-D448-B7AC-DE3A8B663BD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45F4C92-B16C-BE43-A631-D5E084A811A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B5A1DD7F-DE35-CC47-8C48-C61EF646B3E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63D48A0D-B844-0F47-A2C1-375EFE922F0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DCBF140E-A2C1-2543-BBFC-248C6F9A669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00364C-B278-2843-8822-926DA20766C0}" type="datetimeFigureOut">
              <a:rPr lang="en-US" smtClean="0"/>
              <a:t>12/29/21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48C8318B-E034-CF4E-AAD1-F9221036B6B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B1E3B98A-9FDD-404A-8776-C39A7A88AB1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CC74D5-3AC8-1149-9CE2-5C62EA8712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3215838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E0914BF-D8C0-D64C-92C0-381070F443B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71EC489C-AFFC-8448-B426-ECAB1197E2B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00364C-B278-2843-8822-926DA20766C0}" type="datetimeFigureOut">
              <a:rPr lang="en-US" smtClean="0"/>
              <a:t>12/29/21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1C70E9A2-F1EB-8049-9503-FCD003329BD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FC8F9885-AAE4-7749-88B0-53E7C8D9C21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CC74D5-3AC8-1149-9CE2-5C62EA8712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107998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258B2580-0436-FF47-9244-B634023F508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00364C-B278-2843-8822-926DA20766C0}" type="datetimeFigureOut">
              <a:rPr lang="en-US" smtClean="0"/>
              <a:t>12/29/21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7CF1E156-6A2B-6C4C-BD08-02862DC6DDE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BE49AD5A-B541-244E-9AE7-AF16412C376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CC74D5-3AC8-1149-9CE2-5C62EA8712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208205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3958632-DA1B-5A44-82ED-CC7F632F1B0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BB4B549-5F58-8146-B59D-57E90917B6C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E8B0419-A856-154C-AE32-985EDC03C6A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613F830-670E-9A44-B1BE-BFFB6FC51EE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00364C-B278-2843-8822-926DA20766C0}" type="datetimeFigureOut">
              <a:rPr lang="en-US" smtClean="0"/>
              <a:t>12/29/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45814B9-8C59-BE46-80EE-D61795AD4BF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FAE742A-AE91-4344-8AA0-A6D21FE5732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CC74D5-3AC8-1149-9CE2-5C62EA8712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606612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445F534-88EA-E94C-8AA4-CD2B22A6741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4FB7A667-FD2A-9245-9F0F-5EBEC334ED6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E88E360-052F-2F4B-99BE-179BE6FE799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FA288E4-4DA9-1D40-9843-4F2DC3933FC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00364C-B278-2843-8822-926DA20766C0}" type="datetimeFigureOut">
              <a:rPr lang="en-US" smtClean="0"/>
              <a:t>12/29/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AB1EDFB-5EC1-2F49-A97A-ED61E993DE9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014AF67-9E20-B247-98AB-4666FE33737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CC74D5-3AC8-1149-9CE2-5C62EA8712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7850012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CCD93A71-8F10-6D46-89AD-D8B5E2FBA84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F3602C4-95D0-C148-B2C5-937F169841D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7931E5F-CE6F-D342-9268-4485933EE10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000364C-B278-2843-8822-926DA20766C0}" type="datetimeFigureOut">
              <a:rPr lang="en-US" smtClean="0"/>
              <a:t>12/29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145E4C4-DC97-4744-80A4-1810C017D5D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863F3FF-F08B-C549-A989-1204D6B922F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4CC74D5-3AC8-1149-9CE2-5C62EA8712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1585933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tiff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tif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5844BC72-9C5A-3645-87C5-2C374098117D}"/>
              </a:ext>
            </a:extLst>
          </p:cNvPr>
          <p:cNvPicPr/>
          <p:nvPr/>
        </p:nvPicPr>
        <p:blipFill>
          <a:blip r:embed="rId2"/>
          <a:stretch>
            <a:fillRect/>
          </a:stretch>
        </p:blipFill>
        <p:spPr>
          <a:xfrm>
            <a:off x="2324100" y="1692974"/>
            <a:ext cx="6870700" cy="4237926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877997D3-6FD0-D344-B16B-3C580CA4D85F}"/>
              </a:ext>
            </a:extLst>
          </p:cNvPr>
          <p:cNvSpPr txBox="1"/>
          <p:nvPr/>
        </p:nvSpPr>
        <p:spPr>
          <a:xfrm>
            <a:off x="379379" y="729574"/>
            <a:ext cx="106049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Supplemental Figure 1</a:t>
            </a:r>
            <a:r>
              <a:rPr lang="en-US" dirty="0"/>
              <a:t>: Volcano plot of the distribution of genes, mapping the upregulated genes (red crosses).</a:t>
            </a:r>
          </a:p>
        </p:txBody>
      </p:sp>
    </p:spTree>
    <p:extLst>
      <p:ext uri="{BB962C8B-B14F-4D97-AF65-F5344CB8AC3E}">
        <p14:creationId xmlns:p14="http://schemas.microsoft.com/office/powerpoint/2010/main" val="135929371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877997D3-6FD0-D344-B16B-3C580CA4D85F}"/>
              </a:ext>
            </a:extLst>
          </p:cNvPr>
          <p:cNvSpPr txBox="1"/>
          <p:nvPr/>
        </p:nvSpPr>
        <p:spPr>
          <a:xfrm>
            <a:off x="379379" y="729574"/>
            <a:ext cx="995214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Supplemental Figure 2</a:t>
            </a:r>
            <a:r>
              <a:rPr lang="en-US" dirty="0"/>
              <a:t>: Network analysis of interactions between over-represented pathways (</a:t>
            </a:r>
            <a:r>
              <a:rPr lang="en-US" dirty="0" err="1"/>
              <a:t>ClueGO</a:t>
            </a:r>
            <a:r>
              <a:rPr lang="en-US" dirty="0"/>
              <a:t>).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AA0E3064-D7EB-1141-A573-6CC85FADAA21}"/>
              </a:ext>
            </a:extLst>
          </p:cNvPr>
          <p:cNvPicPr/>
          <p:nvPr/>
        </p:nvPicPr>
        <p:blipFill>
          <a:blip r:embed="rId2"/>
          <a:stretch>
            <a:fillRect/>
          </a:stretch>
        </p:blipFill>
        <p:spPr>
          <a:xfrm>
            <a:off x="2719570" y="1549816"/>
            <a:ext cx="7478529" cy="406358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4300968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39E9D6A8-922D-054D-9C52-BFE91CC0455B}"/>
              </a:ext>
            </a:extLst>
          </p:cNvPr>
          <p:cNvPicPr/>
          <p:nvPr/>
        </p:nvPicPr>
        <p:blipFill rotWithShape="1">
          <a:blip r:embed="rId3"/>
          <a:srcRect l="16277" r="12512" b="1662"/>
          <a:stretch/>
        </p:blipFill>
        <p:spPr bwMode="auto">
          <a:xfrm>
            <a:off x="3392885" y="0"/>
            <a:ext cx="7142169" cy="6653719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  <a:ext uri="{53640926-AAD7-44d8-BBD7-CCE9431645EC}">
              <a14:shadowObscured xmlns:lc="http://schemas.openxmlformats.org/drawingml/2006/lockedCanvas" xmlns:arto="http://schemas.microsoft.com/office/word/2006/arto" xmlns:a14="http://schemas.microsoft.com/office/drawing/2010/main" xmlns:w="http://schemas.openxmlformats.org/wordprocessingml/2006/main" xmlns:w10="urn:schemas-microsoft-com:office:word" xmlns:v="urn:schemas-microsoft-com:vml" xmlns:o="urn:schemas-microsoft-com:office:office" xmlns:mv="urn:schemas-microsoft-com:mac:vml" xmlns:mo="http://schemas.microsoft.com/office/mac/office/2008/main" xmlns="" xmlns:pic="http://schemas.openxmlformats.org/drawingml/2006/picture" xmlns:wps="http://schemas.microsoft.com/office/word/2010/wordprocessingShape" xmlns:wne="http://schemas.microsoft.com/office/word/2006/wordml" xmlns:wpi="http://schemas.microsoft.com/office/word/2010/wordprocessingInk" xmlns:wpg="http://schemas.microsoft.com/office/word/2010/wordprocessingGroup" xmlns:w16se="http://schemas.microsoft.com/office/word/2015/wordml/symex" xmlns:w16="http://schemas.microsoft.com/office/word/2018/wordml" xmlns:w16cid="http://schemas.microsoft.com/office/word/2016/wordml/cid" xmlns:w16cex="http://schemas.microsoft.com/office/word/2018/wordml/cex" xmlns:w15="http://schemas.microsoft.com/office/word/2012/wordml" xmlns:w14="http://schemas.microsoft.com/office/word/2010/wordml" xmlns:wp="http://schemas.openxmlformats.org/drawingml/2006/wordprocessingDrawing" xmlns:wp14="http://schemas.microsoft.com/office/word/2010/wordprocessingDrawing" xmlns:m="http://schemas.openxmlformats.org/officeDocument/2006/math" xmlns:am3d="http://schemas.microsoft.com/office/drawing/2017/model3d" xmlns:aink="http://schemas.microsoft.com/office/drawing/2016/ink" xmlns:mc="http://schemas.openxmlformats.org/markup-compatibility/2006" xmlns:cx8="http://schemas.microsoft.com/office/drawing/2016/5/14/chartex" xmlns:cx7="http://schemas.microsoft.com/office/drawing/2016/5/13/chartex" xmlns:cx6="http://schemas.microsoft.com/office/drawing/2016/5/12/chartex" xmlns:cx5="http://schemas.microsoft.com/office/drawing/2016/5/11/chartex" xmlns:cx4="http://schemas.microsoft.com/office/drawing/2016/5/10/chartex" xmlns:cx3="http://schemas.microsoft.com/office/drawing/2016/5/9/chartex" xmlns:cx2="http://schemas.microsoft.com/office/drawing/2015/10/21/chartex" xmlns:cx1="http://schemas.microsoft.com/office/drawing/2015/9/8/chartex" xmlns:cx="http://schemas.microsoft.com/office/drawing/2014/chartex" xmlns:wpc="http://schemas.microsoft.com/office/word/2010/wordprocessingCanvas"/>
            </a:ext>
          </a:extLst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C574B958-EF3E-FE47-87BA-C52430CB880D}"/>
              </a:ext>
            </a:extLst>
          </p:cNvPr>
          <p:cNvSpPr txBox="1"/>
          <p:nvPr/>
        </p:nvSpPr>
        <p:spPr>
          <a:xfrm>
            <a:off x="203366" y="199487"/>
            <a:ext cx="2907160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Supplemental Figure 3:</a:t>
            </a:r>
            <a:r>
              <a:rPr lang="en-US" dirty="0"/>
              <a:t> Integrative network analysis between differentially expressed genes and their pathways.</a:t>
            </a:r>
          </a:p>
        </p:txBody>
      </p:sp>
    </p:spTree>
    <p:extLst>
      <p:ext uri="{BB962C8B-B14F-4D97-AF65-F5344CB8AC3E}">
        <p14:creationId xmlns:p14="http://schemas.microsoft.com/office/powerpoint/2010/main" val="62369486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AFE92210-3B56-F84F-865A-7DDAE7DBE01B}"/>
              </a:ext>
            </a:extLst>
          </p:cNvPr>
          <p:cNvPicPr/>
          <p:nvPr/>
        </p:nvPicPr>
        <p:blipFill>
          <a:blip r:embed="rId2"/>
          <a:stretch>
            <a:fillRect/>
          </a:stretch>
        </p:blipFill>
        <p:spPr>
          <a:xfrm>
            <a:off x="3118484" y="1160780"/>
            <a:ext cx="6800215" cy="4757420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664AAC79-BE14-0442-9552-B8C3A209BA88}"/>
              </a:ext>
            </a:extLst>
          </p:cNvPr>
          <p:cNvSpPr txBox="1"/>
          <p:nvPr/>
        </p:nvSpPr>
        <p:spPr>
          <a:xfrm>
            <a:off x="165370" y="223736"/>
            <a:ext cx="11178491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Supplemental Figure 4</a:t>
            </a:r>
            <a:r>
              <a:rPr lang="en-US" dirty="0"/>
              <a:t>: Integration analysis of differentially expressed gene (pink) network by transcription factors (green) and miRNAs (blue).</a:t>
            </a:r>
          </a:p>
        </p:txBody>
      </p:sp>
    </p:spTree>
    <p:extLst>
      <p:ext uri="{BB962C8B-B14F-4D97-AF65-F5344CB8AC3E}">
        <p14:creationId xmlns:p14="http://schemas.microsoft.com/office/powerpoint/2010/main" val="118236271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6C9F1D50-C898-9443-94EC-64DCB3FD6604}"/>
              </a:ext>
            </a:extLst>
          </p:cNvPr>
          <p:cNvPicPr/>
          <p:nvPr/>
        </p:nvPicPr>
        <p:blipFill>
          <a:blip r:embed="rId2"/>
          <a:stretch>
            <a:fillRect/>
          </a:stretch>
        </p:blipFill>
        <p:spPr>
          <a:xfrm>
            <a:off x="2388931" y="1024768"/>
            <a:ext cx="8574141" cy="5609496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AF2ACB6A-8F60-C74C-8B90-A37BBBDDFE39}"/>
              </a:ext>
            </a:extLst>
          </p:cNvPr>
          <p:cNvSpPr txBox="1"/>
          <p:nvPr/>
        </p:nvSpPr>
        <p:spPr>
          <a:xfrm>
            <a:off x="165370" y="223736"/>
            <a:ext cx="11178491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Supplemental Figure 5: </a:t>
            </a:r>
            <a:r>
              <a:rPr lang="en-US" dirty="0"/>
              <a:t>Protein-protein interaction network identified using STRING database from differentially expressed genes (A). The proteins presenting highest number of </a:t>
            </a:r>
            <a:r>
              <a:rPr lang="en-US" dirty="0" err="1"/>
              <a:t>interctions</a:t>
            </a:r>
            <a:r>
              <a:rPr lang="en-US" dirty="0"/>
              <a:t> (above 15) are presented in the table (B).</a:t>
            </a:r>
          </a:p>
        </p:txBody>
      </p:sp>
    </p:spTree>
    <p:extLst>
      <p:ext uri="{BB962C8B-B14F-4D97-AF65-F5344CB8AC3E}">
        <p14:creationId xmlns:p14="http://schemas.microsoft.com/office/powerpoint/2010/main" val="185543350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9</TotalTime>
  <Words>112</Words>
  <Application>Microsoft Macintosh PowerPoint</Application>
  <PresentationFormat>Widescreen</PresentationFormat>
  <Paragraphs>6</Paragraphs>
  <Slides>5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9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ragan Milenkovic</dc:creator>
  <cp:lastModifiedBy>Dragan Milenkovic</cp:lastModifiedBy>
  <cp:revision>5</cp:revision>
  <dcterms:created xsi:type="dcterms:W3CDTF">2021-04-13T12:17:15Z</dcterms:created>
  <dcterms:modified xsi:type="dcterms:W3CDTF">2021-12-29T15:11:56Z</dcterms:modified>
</cp:coreProperties>
</file>